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15"/>
  </p:normalViewPr>
  <p:slideViewPr>
    <p:cSldViewPr snapToGrid="0" snapToObjects="1">
      <p:cViewPr varScale="1">
        <p:scale>
          <a:sx n="106" d="100"/>
          <a:sy n="106" d="100"/>
        </p:scale>
        <p:origin x="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30FB27E-5E0D-4A48-B811-3F56E27F84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4CB41F1-443B-4F49-ABB3-DB94380BE4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599817D-110E-AB40-9BD4-57943F57A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DF513C6-5D64-B24D-A442-AC8A23FFA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90345FC-11E1-8E44-BB79-B5E6040338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456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2EB13E-80AF-0248-9D0D-9577F8554B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CF2EF54-A6B6-E744-8142-20EF7B9EAB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CBCC80-DBFD-CC40-AC18-E8115599A5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7FD6992-742E-E543-B0A6-20808C137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8ACF129-8705-9846-BE6D-4CA1F9FB8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3977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042BFE9-EE6B-134C-AB1A-E89A231653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9A1C35E-6081-414C-87A8-8EDE908C83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38567CC-F25D-0F4F-8333-FD188AFD4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6F67C59-045C-8A48-AF72-869BFE9F8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107BAF4-EF82-A948-B115-C605B6B171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9510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E02957D-F81F-2F4E-B2DD-CFB2750496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120BEAC-F356-084F-A4EE-6E97974E00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276BBA2-B990-CF41-9F58-9466DD158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2E28097-60C5-8242-9917-DB1A9BCDF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740C7CD-FA06-6F4C-AC50-5E094A4C4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633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7BACB2-3129-984F-A967-9BDBB648B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10F1551-8FF4-6A41-B898-7BDCD174F4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2E1B623-93E2-124B-B582-D5F88732F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31EDA94-130E-124A-AE38-F315D7755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E437114-C40D-F440-8D34-AAFFE01F0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6683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8D14787-A638-4240-ADE9-8A93CA1661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AF8577B-8B3A-4842-BC80-5D2D0074F3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24EC20B-36A8-1644-B55F-574C84DFFE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7A6E769-37CA-174C-850F-EB03F581B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3F04F98-333A-BE47-A4B7-8CE9FF780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14E46EB-FB96-1D4F-B1D6-4CF61A829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7260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9CCDAE-6E22-4047-A65D-D7CA4C5B30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0BD60E0-79C5-624D-873E-54BC69AF17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466846A-29FC-8643-AE3A-E277AEB5AE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A987A4A-D57B-D240-964A-F237CB82EA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E18BA94D-FFD8-CA4D-828F-C2907E3EE9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E3B50EEC-CF4B-4947-A819-7C66753FC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110FE13-54C1-2D42-9F9A-B2E78C5A2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50A9BD9-ED96-144D-AB67-EC4B248B0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1194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A3BDBA9-9CCE-3344-A2E1-AC273992CE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910C113-BE50-1C49-B293-9EC98FCA7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1E0C6A0-B324-6441-97BB-4C95626EE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9543E2B-01D3-5B40-A0A3-05ABBD06F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0223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A30970B-40C1-CA48-9BE8-CB6264999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63956FA-D585-354C-8968-C5F4E2F8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955618E-3926-644A-B800-65435C849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77952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27DB395-13B0-7940-B1FB-AA14CB1788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1F69FA3-B725-8840-A3E2-08B5AA0556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7F2603C-0EFD-D64E-8CA3-649D8646DA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9733AD1-96F2-D343-B5DC-6FEA6919A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A65BF8F-C860-364D-8DA7-35EA571A3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A1C9441-7C66-CF46-9B6B-34614911E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77229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276EF0E-481B-0B4B-A9DF-5564C7832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521EB92-D2C8-DA49-AB5F-6C0801648A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EE56F48-C0D0-2E42-93D5-1E881DDEF2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1154E06-A104-E549-9C78-A5F0FD648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014B0FA-B93D-AA42-8C90-E5AB86936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59971A8-F490-EA4B-AD02-287EBF794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52599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F9E6CF7-03F4-B84E-8744-EAAE766E7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BF81750-5007-FA43-97F5-94552B46E3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056F4EF-B60C-AB40-AFE4-0637A26AE3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B00ED-CCBC-5645-9925-C21A44DFC48F}" type="datetimeFigureOut">
              <a:rPr lang="it-IT" smtClean="0"/>
              <a:t>30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3EA9E1F-64CC-4342-8489-1ECF417C06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87DFA33-A400-304A-8781-4C21EC7B7F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ED6F8F-8586-BF47-80F2-2B84FFD7574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8753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 descr="Immagine che contiene arancia, tavolo, frutta, tenendo&#10;&#10;Descrizione generata automaticamente">
            <a:extLst>
              <a:ext uri="{FF2B5EF4-FFF2-40B4-BE49-F238E27FC236}">
                <a16:creationId xmlns:a16="http://schemas.microsoft.com/office/drawing/2014/main" id="{7243948A-9147-D64D-B24D-C3D4014209F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813" t="20416" r="23229" b="14507"/>
          <a:stretch/>
        </p:blipFill>
        <p:spPr>
          <a:xfrm>
            <a:off x="704689" y="1698625"/>
            <a:ext cx="2370138" cy="2357438"/>
          </a:xfrm>
          <a:prstGeom prst="rect">
            <a:avLst/>
          </a:prstGeom>
        </p:spPr>
      </p:pic>
      <p:pic>
        <p:nvPicPr>
          <p:cNvPr id="9" name="Immagine 8" descr="Immagine che contiene cibo, tavolo, blu, pezzo&#10;&#10;Descrizione generata automaticamente">
            <a:extLst>
              <a:ext uri="{FF2B5EF4-FFF2-40B4-BE49-F238E27FC236}">
                <a16:creationId xmlns:a16="http://schemas.microsoft.com/office/drawing/2014/main" id="{7D6D9CE0-DEA8-2048-B179-6B447E8A99E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583" t="3148" r="13351" b="29630"/>
          <a:stretch/>
        </p:blipFill>
        <p:spPr>
          <a:xfrm>
            <a:off x="3370080" y="1696468"/>
            <a:ext cx="2628000" cy="2321786"/>
          </a:xfrm>
          <a:prstGeom prst="rect">
            <a:avLst/>
          </a:prstGeom>
        </p:spPr>
      </p:pic>
      <p:pic>
        <p:nvPicPr>
          <p:cNvPr id="12" name="Immagine 11" descr="Immagine che contiene pepe, diverso, sedendo, colorato&#10;&#10;Descrizione generata automaticamente">
            <a:extLst>
              <a:ext uri="{FF2B5EF4-FFF2-40B4-BE49-F238E27FC236}">
                <a16:creationId xmlns:a16="http://schemas.microsoft.com/office/drawing/2014/main" id="{DD0FE7F1-0141-6747-B659-6DEE50517D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13599" y="1674451"/>
            <a:ext cx="2082089" cy="2381612"/>
          </a:xfrm>
          <a:prstGeom prst="rect">
            <a:avLst/>
          </a:prstGeom>
        </p:spPr>
      </p:pic>
      <p:pic>
        <p:nvPicPr>
          <p:cNvPr id="14" name="Immagine 13" descr="Immagine che contiene cibo, interni, tavolo, asse&#10;&#10;Descrizione generata automaticamente">
            <a:extLst>
              <a:ext uri="{FF2B5EF4-FFF2-40B4-BE49-F238E27FC236}">
                <a16:creationId xmlns:a16="http://schemas.microsoft.com/office/drawing/2014/main" id="{BC3D535C-8106-3C42-A23B-1157D97E67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90941" y="1696468"/>
            <a:ext cx="2169260" cy="2381612"/>
          </a:xfrm>
          <a:prstGeom prst="rect">
            <a:avLst/>
          </a:prstGeom>
        </p:spPr>
      </p:pic>
      <p:cxnSp>
        <p:nvCxnSpPr>
          <p:cNvPr id="16" name="Connettore 1 15">
            <a:extLst>
              <a:ext uri="{FF2B5EF4-FFF2-40B4-BE49-F238E27FC236}">
                <a16:creationId xmlns:a16="http://schemas.microsoft.com/office/drawing/2014/main" id="{BD962C84-4A32-1148-9AAF-668F5BF6A8AA}"/>
              </a:ext>
            </a:extLst>
          </p:cNvPr>
          <p:cNvCxnSpPr>
            <a:cxnSpLocks/>
          </p:cNvCxnSpPr>
          <p:nvPr/>
        </p:nvCxnSpPr>
        <p:spPr>
          <a:xfrm>
            <a:off x="704689" y="1463675"/>
            <a:ext cx="4740276" cy="0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ttore 1 18">
            <a:extLst>
              <a:ext uri="{FF2B5EF4-FFF2-40B4-BE49-F238E27FC236}">
                <a16:creationId xmlns:a16="http://schemas.microsoft.com/office/drawing/2014/main" id="{301726DA-CB50-944B-88E9-AE5CF1D0AC0B}"/>
              </a:ext>
            </a:extLst>
          </p:cNvPr>
          <p:cNvCxnSpPr>
            <a:cxnSpLocks/>
          </p:cNvCxnSpPr>
          <p:nvPr/>
        </p:nvCxnSpPr>
        <p:spPr>
          <a:xfrm>
            <a:off x="7019925" y="1463675"/>
            <a:ext cx="4740276" cy="0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B128DA1E-FBE6-C848-AD3F-FD036867B5CE}"/>
              </a:ext>
            </a:extLst>
          </p:cNvPr>
          <p:cNvSpPr txBox="1"/>
          <p:nvPr/>
        </p:nvSpPr>
        <p:spPr>
          <a:xfrm>
            <a:off x="1642879" y="940455"/>
            <a:ext cx="31720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>
                <a:latin typeface="Calibri "/>
                <a:cs typeface="Times New Roman" panose="02020603050405020304" pitchFamily="18" charset="0"/>
              </a:rPr>
              <a:t>Campania </a:t>
            </a:r>
            <a:r>
              <a:rPr lang="it-IT" sz="2400" dirty="0" err="1">
                <a:latin typeface="Calibri "/>
                <a:cs typeface="Times New Roman" panose="02020603050405020304" pitchFamily="18" charset="0"/>
              </a:rPr>
              <a:t>provenance</a:t>
            </a:r>
            <a:endParaRPr lang="it-IT" sz="2400" dirty="0">
              <a:latin typeface="Calibri "/>
              <a:cs typeface="Times New Roman" panose="02020603050405020304" pitchFamily="18" charset="0"/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D78ADD4A-8F9D-154F-A320-8F4883024175}"/>
              </a:ext>
            </a:extLst>
          </p:cNvPr>
          <p:cNvSpPr txBox="1"/>
          <p:nvPr/>
        </p:nvSpPr>
        <p:spPr>
          <a:xfrm>
            <a:off x="8133523" y="940455"/>
            <a:ext cx="31720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>
                <a:latin typeface="Calibri "/>
                <a:cs typeface="Times New Roman" panose="02020603050405020304" pitchFamily="18" charset="0"/>
              </a:rPr>
              <a:t>Calabria </a:t>
            </a:r>
            <a:r>
              <a:rPr lang="it-IT" sz="2400" dirty="0" err="1">
                <a:latin typeface="Calibri "/>
                <a:cs typeface="Times New Roman" panose="02020603050405020304" pitchFamily="18" charset="0"/>
              </a:rPr>
              <a:t>provenance</a:t>
            </a:r>
            <a:endParaRPr lang="it-IT" sz="2400" dirty="0">
              <a:latin typeface="Calibri "/>
              <a:cs typeface="Times New Roman" panose="02020603050405020304" pitchFamily="18" charset="0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7ECCE8A7-311D-E040-BED2-0AD58C630399}"/>
              </a:ext>
            </a:extLst>
          </p:cNvPr>
          <p:cNvSpPr txBox="1"/>
          <p:nvPr/>
        </p:nvSpPr>
        <p:spPr>
          <a:xfrm>
            <a:off x="242680" y="891359"/>
            <a:ext cx="6686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latin typeface="Calibri "/>
                <a:cs typeface="Times New Roman" panose="02020603050405020304" pitchFamily="18" charset="0"/>
              </a:rPr>
              <a:t>a</a:t>
            </a:r>
            <a:r>
              <a:rPr lang="it-IT" sz="2400" dirty="0">
                <a:latin typeface="Calibri 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DB5725E6-9A5F-CE44-83E4-83AA95C3B722}"/>
              </a:ext>
            </a:extLst>
          </p:cNvPr>
          <p:cNvSpPr txBox="1"/>
          <p:nvPr/>
        </p:nvSpPr>
        <p:spPr>
          <a:xfrm>
            <a:off x="6685583" y="891359"/>
            <a:ext cx="6686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latin typeface="Calibri "/>
                <a:cs typeface="Times New Roman" panose="02020603050405020304" pitchFamily="18" charset="0"/>
              </a:rPr>
              <a:t>b</a:t>
            </a:r>
            <a:r>
              <a:rPr lang="it-IT" sz="2400" dirty="0">
                <a:latin typeface="Calibri 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BC927FD5-6741-ED40-9C6B-66DF2E99D274}"/>
              </a:ext>
            </a:extLst>
          </p:cNvPr>
          <p:cNvSpPr txBox="1"/>
          <p:nvPr/>
        </p:nvSpPr>
        <p:spPr>
          <a:xfrm>
            <a:off x="1524076" y="4021249"/>
            <a:ext cx="7313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dirty="0">
                <a:latin typeface="Calibri "/>
                <a:cs typeface="Times New Roman" panose="02020603050405020304" pitchFamily="18" charset="0"/>
              </a:rPr>
              <a:t>CDT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ABFA8264-BBAF-D944-9AEB-1B59EFA86FA8}"/>
              </a:ext>
            </a:extLst>
          </p:cNvPr>
          <p:cNvSpPr txBox="1"/>
          <p:nvPr/>
        </p:nvSpPr>
        <p:spPr>
          <a:xfrm>
            <a:off x="4340836" y="4068353"/>
            <a:ext cx="7313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dirty="0">
                <a:latin typeface="Calibri "/>
                <a:cs typeface="Times New Roman" panose="02020603050405020304" pitchFamily="18" charset="0"/>
              </a:rPr>
              <a:t>PAP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44E4DD10-D8EB-EC43-A0D5-2DDEE0791DC1}"/>
              </a:ext>
            </a:extLst>
          </p:cNvPr>
          <p:cNvSpPr txBox="1"/>
          <p:nvPr/>
        </p:nvSpPr>
        <p:spPr>
          <a:xfrm>
            <a:off x="7888961" y="4078080"/>
            <a:ext cx="7313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dirty="0">
                <a:latin typeface="Calibri "/>
                <a:cs typeface="Times New Roman" panose="02020603050405020304" pitchFamily="18" charset="0"/>
              </a:rPr>
              <a:t>SIG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B6FB03B4-F17C-4C46-9012-8CA5AF7CEA50}"/>
              </a:ext>
            </a:extLst>
          </p:cNvPr>
          <p:cNvSpPr txBox="1"/>
          <p:nvPr/>
        </p:nvSpPr>
        <p:spPr>
          <a:xfrm>
            <a:off x="10511207" y="4056845"/>
            <a:ext cx="7172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dirty="0">
                <a:latin typeface="Calibri "/>
                <a:cs typeface="Times New Roman" panose="02020603050405020304" pitchFamily="18" charset="0"/>
              </a:rPr>
              <a:t>CIL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B023BFBE-D38E-4AD7-ACD4-82C16CF5D523}"/>
              </a:ext>
            </a:extLst>
          </p:cNvPr>
          <p:cNvSpPr txBox="1"/>
          <p:nvPr/>
        </p:nvSpPr>
        <p:spPr>
          <a:xfrm>
            <a:off x="48260" y="6407913"/>
            <a:ext cx="98187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Figure S1</a:t>
            </a:r>
            <a:r>
              <a:rPr lang="it-IT" sz="1200" dirty="0"/>
              <a:t>:  </a:t>
            </a:r>
            <a:r>
              <a:rPr lang="it-IT" sz="1200" dirty="0" err="1"/>
              <a:t>Traditional</a:t>
            </a:r>
            <a:r>
              <a:rPr lang="it-IT" sz="1200" dirty="0"/>
              <a:t> </a:t>
            </a:r>
            <a:r>
              <a:rPr lang="it-IT" sz="1200" dirty="0" err="1"/>
              <a:t>varieties</a:t>
            </a:r>
            <a:r>
              <a:rPr lang="it-IT" sz="1200" dirty="0"/>
              <a:t> </a:t>
            </a:r>
            <a:r>
              <a:rPr lang="it-IT" sz="1200" dirty="0" err="1"/>
              <a:t>considered</a:t>
            </a:r>
            <a:r>
              <a:rPr lang="it-IT" sz="1200" dirty="0"/>
              <a:t> in the </a:t>
            </a:r>
            <a:r>
              <a:rPr lang="it-IT" sz="1200" dirty="0" err="1"/>
              <a:t>present</a:t>
            </a:r>
            <a:r>
              <a:rPr lang="it-IT" sz="1200" dirty="0"/>
              <a:t> study and </a:t>
            </a:r>
            <a:r>
              <a:rPr lang="it-IT" sz="1200" dirty="0" err="1"/>
              <a:t>their</a:t>
            </a:r>
            <a:r>
              <a:rPr lang="it-IT" sz="1200" dirty="0"/>
              <a:t> </a:t>
            </a:r>
            <a:r>
              <a:rPr lang="it-IT" sz="1200" dirty="0" err="1"/>
              <a:t>provenance</a:t>
            </a:r>
            <a:r>
              <a:rPr lang="it-IT" sz="1200" dirty="0"/>
              <a:t>. CDT = Corno di toro; PAP = </a:t>
            </a:r>
            <a:r>
              <a:rPr lang="it-IT" sz="1200" dirty="0" err="1"/>
              <a:t>Papaccella</a:t>
            </a:r>
            <a:r>
              <a:rPr lang="it-IT" sz="1200" dirty="0"/>
              <a:t>; SIG = Sigaretta; CIL = Ciliegino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3128655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43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salvatore esposito</cp:lastModifiedBy>
  <cp:revision>9</cp:revision>
  <dcterms:created xsi:type="dcterms:W3CDTF">2020-08-21T15:59:14Z</dcterms:created>
  <dcterms:modified xsi:type="dcterms:W3CDTF">2021-09-30T10:53:50Z</dcterms:modified>
</cp:coreProperties>
</file>